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  <p:sldId id="279" r:id="rId3"/>
    <p:sldId id="280" r:id="rId4"/>
    <p:sldId id="28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22E22E6-AF03-468A-89FE-C127613FDE3C}" v="39" dt="2020-11-30T21:23:05.87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561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331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038C85-97CB-4A6C-91CB-099DDA2F69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670EFAF-84CF-40F0-BEF1-C42678B808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938B3E-F8B3-44A4-83E4-F3C50E5F8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F094E-9FBE-4DDA-9F88-80A4A0995F74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E73EC2-2E77-489A-8E14-82B88C271A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B629E3-138E-420A-8D2D-1A9EDFDFD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3FE65-7ABF-4B63-A0BC-19094F3A2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0013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75B1C1-219D-4B68-BE2D-DC31D031DE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1897F9-9E4B-4CFC-B96B-B88EC65D59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1CED7B-B86D-4594-B828-8FACC4A98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F094E-9FBE-4DDA-9F88-80A4A0995F74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F7EBD7-DA9B-4B44-A1B7-C5809C7D5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B8FE66-0336-4948-8C8F-FBDFD23F7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3FE65-7ABF-4B63-A0BC-19094F3A2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988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1878482-ED95-4237-A3DA-F72A936A8A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992D7C-EF33-4773-905F-232114BCD9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240E6C-E1A4-4E62-9651-5C499F156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F094E-9FBE-4DDA-9F88-80A4A0995F74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42A4D1-7892-4407-B735-3C1C58CDE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BD69FB-7314-4E17-8E4D-85FA7CE6B9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3FE65-7ABF-4B63-A0BC-19094F3A2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805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3FF5F1-62DE-4743-BC60-71F1680673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6BB4EC-BBCC-4BE3-B778-2E0638A5C8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D5D9BD-BA32-4DFA-840D-FDCFA5166E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F094E-9FBE-4DDA-9F88-80A4A0995F74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E83338-5844-4084-9446-518F7D7A2C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811A97-DED5-49DC-87BC-758CC7CA8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3FE65-7ABF-4B63-A0BC-19094F3A2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069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590958-EDA2-4F81-881D-02C40F1C8E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49DE28-CC98-4C2B-8ECC-2122E5D73E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787CC8-1CA8-4C88-BFFE-3CCD5BA082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F094E-9FBE-4DDA-9F88-80A4A0995F74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6849AA-031C-40E3-9048-158351007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D2AF67-3837-4015-ACB5-A83C54724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3FE65-7ABF-4B63-A0BC-19094F3A2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770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631F4C-C22F-4EF5-A56A-52409E214C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D1D5E0-E27E-41EE-9BC6-A66CB08B73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7D4D7A-EEC3-4D1E-9C80-CC9D3F9C41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6AF06E-5262-453D-BB14-CD9E57E1F1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F094E-9FBE-4DDA-9F88-80A4A0995F74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D10849-F2ED-4DE1-B3CF-A67EA3411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A7D3D2-DE6B-48F1-B0D9-B6843BB2AD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3FE65-7ABF-4B63-A0BC-19094F3A2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59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CEBF58-D496-48AF-B99C-7F60F28046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92DEC7-21A4-48E1-BAA9-89F3583643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EA657D-39D5-4F75-930A-37304F55B3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5B6A476-B060-4465-8AC9-6FC76F4989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9550BC-BA22-4575-A28D-A3CE4965FB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40FA2EB-B427-4C7F-B2B5-2D842BCED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F094E-9FBE-4DDA-9F88-80A4A0995F74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7503A10-BB7B-4901-87E3-C1FBCAB8FD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D1A5EE-A8D8-4826-BC3B-9BA2B72C1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3FE65-7ABF-4B63-A0BC-19094F3A2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888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2289DB-BF3A-4054-A451-AA172AD41B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C3677F4-2C0B-4BB8-9289-5235FCAE5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F094E-9FBE-4DDA-9F88-80A4A0995F74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7E2CB89-527E-4A98-A2E8-57F4BA910B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917868-71E5-4563-BBCB-FBB67E8DC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3FE65-7ABF-4B63-A0BC-19094F3A2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679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CBD7696-D5C4-40F6-A151-9747905B69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F094E-9FBE-4DDA-9F88-80A4A0995F74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32EEC6-D261-42DA-B91F-89D4A82CB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2D88B8-4011-443D-BF07-280993A1E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3FE65-7ABF-4B63-A0BC-19094F3A2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33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4B192F-303B-4C32-978F-6F68718835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563CD7-4E14-4664-B435-A2A90FC827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D04BAA-B8BF-4620-AAA8-7890A35BF3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DC8059-6773-4BFF-B0F5-444400175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F094E-9FBE-4DDA-9F88-80A4A0995F74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19956A-5D05-4A48-AFE7-1800CDC9EB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72CF24-BE0F-4F3A-B0AE-E0F5B2BB22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3FE65-7ABF-4B63-A0BC-19094F3A2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7338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1C000F-BAA5-45F2-A297-06F15D47EC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BDFB12-8454-4A9B-B5F7-64514CAFF1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F0F30F-5914-48F2-9141-5B418CFF5B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C6E10C-69C0-44CE-B12B-DE03849CC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F094E-9FBE-4DDA-9F88-80A4A0995F74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C197C5-EA6D-47D8-99FA-7339C4C6EE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F20CE9-8F5A-4E90-96F5-95EE96380A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3FE65-7ABF-4B63-A0BC-19094F3A2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893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7B01EC-CB72-4337-ABFB-B15694AEB8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26D043-E006-42AC-B21F-A8FC3C7CE7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4247F7-82BC-42EC-803C-F52DE7757D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8F094E-9FBE-4DDA-9F88-80A4A0995F74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C5FEA4-F745-4800-BD89-5B3EBEB8EC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E7B37B-7ECB-454B-82F0-587204323E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83FE65-7ABF-4B63-A0BC-19094F3A2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070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3082" y="1334924"/>
            <a:ext cx="4030735" cy="49106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327804"/>
            <a:ext cx="12191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atechin and Epicatechi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2690" y="6245524"/>
            <a:ext cx="54915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he different XICs are to show that the other peaks showing up in the chromatogram at 3.8 min are from other compounds with slightly different elution time/peak shape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6648" y="1587259"/>
            <a:ext cx="5062727" cy="41457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59881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7617" y="1075303"/>
            <a:ext cx="5215213" cy="474317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396815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Epicatechin</a:t>
            </a:r>
            <a:r>
              <a:rPr lang="en-US" dirty="0"/>
              <a:t> </a:t>
            </a:r>
            <a:r>
              <a:rPr lang="en-US" dirty="0" err="1"/>
              <a:t>gallate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33463" y="1709976"/>
            <a:ext cx="4226169" cy="34738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97554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5621" y="1519454"/>
            <a:ext cx="5273308" cy="430610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448574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Procyanidins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0808" y="1213249"/>
            <a:ext cx="4990399" cy="4763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51372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408" y="1362202"/>
            <a:ext cx="5540825" cy="451073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379562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rocyanidin B2 3'-O-gallate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81661" y="1768414"/>
            <a:ext cx="4650744" cy="38716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62977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7</TotalTime>
  <Words>41</Words>
  <Application>Microsoft Office PowerPoint</Application>
  <PresentationFormat>Widescreen</PresentationFormat>
  <Paragraphs>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ilmiller, Anthony</dc:creator>
  <cp:lastModifiedBy>Joshua VanderWeide</cp:lastModifiedBy>
  <cp:revision>17</cp:revision>
  <dcterms:created xsi:type="dcterms:W3CDTF">2020-11-30T14:24:57Z</dcterms:created>
  <dcterms:modified xsi:type="dcterms:W3CDTF">2021-07-01T18:47:06Z</dcterms:modified>
</cp:coreProperties>
</file>